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4" r:id="rId2"/>
    <p:sldId id="268" r:id="rId3"/>
    <p:sldId id="258" r:id="rId4"/>
    <p:sldId id="259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ittlere Formatvorlag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ittlere Formatvorlage 3 - Akz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Mittlere Formatvorlage 3 - Akz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711"/>
    <p:restoredTop sz="65359"/>
  </p:normalViewPr>
  <p:slideViewPr>
    <p:cSldViewPr snapToGrid="0" snapToObjects="1">
      <p:cViewPr varScale="1">
        <p:scale>
          <a:sx n="76" d="100"/>
          <a:sy n="76" d="100"/>
        </p:scale>
        <p:origin x="1176" y="84"/>
      </p:cViewPr>
      <p:guideLst/>
    </p:cSldViewPr>
  </p:slideViewPr>
  <p:notesTextViewPr>
    <p:cViewPr>
      <p:scale>
        <a:sx n="90" d="100"/>
        <a:sy n="9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A63919-AF90-624D-BED9-E454DE1B0FB8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15EE1D-0777-6B45-9CD5-4D9911A16B3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6369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 bwMode="auto"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 bwMode="auto"/>
        <p:txBody>
          <a:bodyPr/>
          <a:lstStyle/>
          <a:p>
            <a:pPr marL="0" marR="0" indent="0" algn="l" defTabSz="9144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de-DE" dirty="0"/>
              <a:t>In </a:t>
            </a:r>
            <a:r>
              <a:rPr lang="de-DE" dirty="0" err="1"/>
              <a:t>case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everal</a:t>
            </a:r>
            <a:r>
              <a:rPr lang="de-DE" dirty="0"/>
              <a:t> relevant </a:t>
            </a:r>
            <a:r>
              <a:rPr lang="de-DE" dirty="0" err="1"/>
              <a:t>features</a:t>
            </a:r>
            <a:r>
              <a:rPr lang="de-DE" dirty="0"/>
              <a:t> per </a:t>
            </a:r>
            <a:r>
              <a:rPr lang="de-DE" dirty="0" err="1"/>
              <a:t>response</a:t>
            </a:r>
            <a:r>
              <a:rPr lang="de-DE" dirty="0"/>
              <a:t> </a:t>
            </a:r>
            <a:r>
              <a:rPr lang="de-DE" dirty="0" err="1"/>
              <a:t>criterion</a:t>
            </a:r>
            <a:r>
              <a:rPr lang="de-DE" dirty="0"/>
              <a:t> a </a:t>
            </a:r>
            <a:r>
              <a:rPr lang="de-DE" dirty="0" err="1"/>
              <a:t>correlation</a:t>
            </a:r>
            <a:r>
              <a:rPr lang="de-DE" dirty="0"/>
              <a:t> </a:t>
            </a:r>
            <a:r>
              <a:rPr lang="de-DE" dirty="0" err="1"/>
              <a:t>matrix</a:t>
            </a:r>
            <a:r>
              <a:rPr lang="de-DE" dirty="0"/>
              <a:t> was </a:t>
            </a:r>
            <a:r>
              <a:rPr lang="de-DE" dirty="0" err="1"/>
              <a:t>calculated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achievement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n </a:t>
            </a:r>
            <a:r>
              <a:rPr lang="de-DE" dirty="0" err="1"/>
              <a:t>increase</a:t>
            </a:r>
            <a:r>
              <a:rPr lang="de-DE" dirty="0"/>
              <a:t> in TESS score </a:t>
            </a:r>
            <a:r>
              <a:rPr lang="de-DE" dirty="0" err="1"/>
              <a:t>of</a:t>
            </a:r>
            <a:r>
              <a:rPr lang="de-DE" dirty="0"/>
              <a:t> at least 5% after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first</a:t>
            </a:r>
            <a:r>
              <a:rPr lang="de-DE" dirty="0"/>
              <a:t> </a:t>
            </a:r>
            <a:r>
              <a:rPr lang="de-DE" dirty="0" err="1"/>
              <a:t>therapy</a:t>
            </a:r>
            <a:r>
              <a:rPr lang="de-DE" dirty="0"/>
              <a:t> (DELTA-RF) (a) </a:t>
            </a:r>
            <a:r>
              <a:rPr lang="de-DE" dirty="0" err="1"/>
              <a:t>or</a:t>
            </a:r>
            <a:r>
              <a:rPr lang="de-DE" dirty="0"/>
              <a:t> </a:t>
            </a:r>
            <a:r>
              <a:rPr lang="de-DE" dirty="0" err="1"/>
              <a:t>achievement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 </a:t>
            </a:r>
            <a:r>
              <a:rPr lang="de-DE" dirty="0" err="1"/>
              <a:t>pain</a:t>
            </a:r>
            <a:r>
              <a:rPr lang="de-DE" dirty="0"/>
              <a:t> score </a:t>
            </a:r>
            <a:r>
              <a:rPr lang="de-DE" dirty="0" err="1"/>
              <a:t>of</a:t>
            </a:r>
            <a:r>
              <a:rPr lang="de-DE" dirty="0"/>
              <a:t> at least 85 </a:t>
            </a:r>
            <a:r>
              <a:rPr lang="de-DE" dirty="0" err="1"/>
              <a:t>points</a:t>
            </a:r>
            <a:r>
              <a:rPr lang="de-DE" dirty="0"/>
              <a:t> </a:t>
            </a:r>
            <a:r>
              <a:rPr lang="de-DE" dirty="0" err="1"/>
              <a:t>assessed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SF-36 (b). </a:t>
            </a:r>
            <a:r>
              <a:rPr lang="en-US" dirty="0"/>
              <a:t>Correlogram including independent radiomic features where</a:t>
            </a:r>
            <a:r>
              <a:rPr lang="en-US" baseline="0" dirty="0"/>
              <a:t> </a:t>
            </a:r>
            <a:r>
              <a:rPr lang="en-US" dirty="0"/>
              <a:t>clusters of textural features became apparent. These indicate a strong correlation between parameters of the same imaging method. Blue circles indicate positive correlation, red circles negative correlation.</a:t>
            </a:r>
            <a:endParaRPr lang="de-DE" dirty="0"/>
          </a:p>
          <a:p>
            <a:pPr marL="0" marR="0" indent="0" algn="l" defTabSz="9144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lang="de-DE" sz="1200" b="0" i="0" dirty="0">
              <a:solidFill>
                <a:schemeClr val="tx1"/>
              </a:solidFill>
              <a:latin typeface="Calibri"/>
              <a:cs typeface="Arial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 bwMode="auto"/>
        <p:txBody>
          <a:bodyPr/>
          <a:lstStyle/>
          <a:p>
            <a:pPr>
              <a:defRPr/>
            </a:pPr>
            <a:fld id="{E5248BE9-865B-6641-8A34-B11A943B9115}" type="slidenum">
              <a:rPr lang="de-DE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13491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tistical data of the QoL surveys after the first percutaneous sclerotherapy (a) and after repetitive PS (b). </a:t>
            </a:r>
            <a:endParaRPr lang="de-DE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15EE1D-0777-6B45-9CD5-4D9911A16B32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011901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Supplementary Table </a:t>
            </a:r>
            <a:r>
              <a:rPr lang="de-DE" dirty="0" smtClean="0"/>
              <a:t>S2</a:t>
            </a:r>
            <a:r>
              <a:rPr lang="de-DE" dirty="0"/>
              <a:t>: Outcome details of the individual patients (1 – outcome was achieved, 0 – outcome was not achieved) after the first PS (improvement in SF-36 pain of at least 20 points or improvement in TESS score of at least 5 %) and after repetitive PS (achievement of a pain score of at least 85 points assessed with the SF-36 or of a TESS score of at least 85%). 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15EE1D-0777-6B45-9CD5-4D9911A16B32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09506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Outcome </a:t>
            </a:r>
            <a:r>
              <a:rPr lang="de-DE" dirty="0" err="1"/>
              <a:t>prediction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binary</a:t>
            </a:r>
            <a:r>
              <a:rPr lang="de-DE" dirty="0"/>
              <a:t> </a:t>
            </a:r>
            <a:r>
              <a:rPr lang="de-DE" dirty="0" err="1"/>
              <a:t>logistic</a:t>
            </a:r>
            <a:r>
              <a:rPr lang="de-DE" dirty="0"/>
              <a:t> </a:t>
            </a:r>
            <a:r>
              <a:rPr lang="de-DE" dirty="0" err="1"/>
              <a:t>regression</a:t>
            </a:r>
            <a:r>
              <a:rPr lang="de-DE" dirty="0"/>
              <a:t> </a:t>
            </a:r>
            <a:r>
              <a:rPr lang="de-DE" dirty="0" err="1"/>
              <a:t>revealed</a:t>
            </a:r>
            <a:r>
              <a:rPr lang="de-DE" dirty="0"/>
              <a:t> </a:t>
            </a:r>
            <a:r>
              <a:rPr lang="de-DE" dirty="0" err="1"/>
              <a:t>no</a:t>
            </a:r>
            <a:r>
              <a:rPr lang="de-DE" dirty="0"/>
              <a:t> </a:t>
            </a:r>
            <a:r>
              <a:rPr lang="de-DE" dirty="0" err="1"/>
              <a:t>statistical</a:t>
            </a:r>
            <a:r>
              <a:rPr lang="de-DE" dirty="0"/>
              <a:t> </a:t>
            </a:r>
            <a:r>
              <a:rPr lang="de-DE" dirty="0" err="1"/>
              <a:t>significance</a:t>
            </a:r>
            <a:r>
              <a:rPr lang="de-DE" dirty="0"/>
              <a:t> </a:t>
            </a:r>
            <a:r>
              <a:rPr lang="de-DE" dirty="0" err="1"/>
              <a:t>regarding</a:t>
            </a:r>
            <a:r>
              <a:rPr lang="de-DE" dirty="0"/>
              <a:t> </a:t>
            </a:r>
            <a:r>
              <a:rPr lang="de-DE" dirty="0" err="1"/>
              <a:t>basic</a:t>
            </a:r>
            <a:r>
              <a:rPr lang="de-DE" dirty="0"/>
              <a:t> </a:t>
            </a:r>
            <a:r>
              <a:rPr lang="de-DE" dirty="0" err="1"/>
              <a:t>characteristic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or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interventional</a:t>
            </a:r>
            <a:r>
              <a:rPr lang="de-DE" dirty="0"/>
              <a:t> </a:t>
            </a:r>
            <a:r>
              <a:rPr lang="de-DE" dirty="0" err="1"/>
              <a:t>procedure</a:t>
            </a:r>
            <a:r>
              <a:rPr lang="de-DE" dirty="0"/>
              <a:t> </a:t>
            </a:r>
            <a:r>
              <a:rPr lang="de-DE" dirty="0" err="1"/>
              <a:t>regarding</a:t>
            </a:r>
            <a:r>
              <a:rPr lang="de-DE" dirty="0"/>
              <a:t> </a:t>
            </a:r>
            <a:r>
              <a:rPr lang="de-DE" dirty="0" err="1"/>
              <a:t>outcome</a:t>
            </a:r>
            <a:r>
              <a:rPr lang="de-DE" dirty="0"/>
              <a:t> after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first</a:t>
            </a:r>
            <a:r>
              <a:rPr lang="de-DE" dirty="0"/>
              <a:t> PS (a) </a:t>
            </a:r>
            <a:r>
              <a:rPr lang="de-DE" dirty="0" err="1"/>
              <a:t>or</a:t>
            </a:r>
            <a:r>
              <a:rPr lang="de-DE" dirty="0"/>
              <a:t> after repetitive PS (b).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15EE1D-0777-6B45-9CD5-4D9911A16B32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94503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8CE4E8E7-9F25-2440-9B55-75DA932AE9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8089A9B2-FDF6-044D-A33F-37C371C13E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2D588B4A-D4F0-AD45-B9E7-B5F894786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618AD194-B842-8C4F-B717-66857B7A7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B5176918-F568-FA43-9FA4-535CD8193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1234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D642A02E-83F4-AF4F-9F4C-E0C2D38330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79929DA4-D688-A94F-BD38-C781CE826B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5B4134F5-321A-C341-B946-3DE733BBC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AD495BC3-F576-0142-A80D-A8E1D3CCE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E4830778-23B1-4C45-B158-87D4E6167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362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9D54D970-D0A5-8047-9F91-9C513EB8FF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E97C5FA9-A333-0944-86AB-C703BCA663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D1F74DCF-1DE1-784E-9F7C-1CE8DFC1A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32163EF4-93A1-A941-A54C-885B7A8BD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9A4982F0-65A4-C34C-A6E8-B1B377D2E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8772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75410AB4-4492-4948-9E4C-ABC5F39682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6B6D518B-454E-1C4B-9EED-9430DBC5E4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67826C09-9897-7C49-B3AB-4C6B15D00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70383043-897A-344E-BD31-F57F3E8DA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270C7437-4873-9047-990D-95F7C0311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9956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B294DAF8-CAA0-964C-814C-D50280D2A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0269F76D-1D43-B243-8E09-8E99D8BEA4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51276475-0FBC-EB4D-A323-85938A1E7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BE192F2C-1DF0-EE42-8FB6-12AAB0AB39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B832657C-9650-1C45-84D5-72E6B88E7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1188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648D3B6-C263-764E-9C32-E97D392B24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1968E08C-3863-9648-90E9-97661EFDEF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618A4E89-D398-E849-9F24-143A82C067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C9B39680-EA30-444A-8966-132FF6F8B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414369D1-D7D8-E042-BC54-678B467C5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73A55241-4451-6B4F-9B58-8696F80411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4201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3193F8A5-A912-6F47-9F02-534F8288E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3425A4C2-23A6-0149-BB80-8BD5B99536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D0CD2742-CCCD-064E-9C2E-EB51062F60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73DFB595-ED87-FB4D-90CF-66B552072F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142F2BB9-6015-0044-B3C8-5E40369C0D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E9BD6E1C-C65A-334B-B7B9-ED53FFB77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49672D8D-C349-4D4D-85D8-5FE72856D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0D81D547-1627-9E42-BF9E-56C781463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2314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7F8A266-B968-0E46-B78E-4FDF9F702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6DF69723-F475-1F43-8AA1-69DAC6AD6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DC55B5A3-FA0E-A547-BFBD-D30B095ED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88E20559-ED52-F844-B988-7AA1DB2FF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3077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94938EC3-6331-3445-9A89-22F3AD760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0A8782FB-D432-5E4D-A975-F91601DAC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FCA003B1-13C5-6F40-A507-DEA80D0D7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5814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465E57C-CF87-C248-BDB1-FA6F5A57B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3D00F128-58B4-A644-8D86-F87E0B95BB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C43AFE3E-8266-2D4F-884F-7BC6AB2461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9B39BC8D-DFC7-3649-B109-6B696AD78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1D82A10D-29F6-D449-99AA-3739ABADC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5385101F-6298-504C-9FC6-CBF2B7DB5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9085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D40E45EA-FF0C-8D48-A0A9-BE7D2441A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AB6724FC-6AA1-2542-A731-BBD8B0B945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A64384A0-B0E4-8A46-8500-05B463BF7E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CE94839C-A5F3-9646-9463-3A132C0D1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12756631-5A57-7044-B3A9-70F67A12EB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C764FD6F-93C8-134A-B86F-6CA276482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5380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37431A68-41A7-C24A-B648-F29DE0AFA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B557EDDE-0679-AE4A-9DD3-C64EBDD0E1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4619AFD5-1CD4-854E-813A-A68B5D37B6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ABD5C-CA36-6D43-892F-50507A0D0D36}" type="datetimeFigureOut">
              <a:rPr lang="de-DE" smtClean="0"/>
              <a:t>09.06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2ABA81FC-8855-E249-BAD6-3BF9488D04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6B3A5871-1421-A74B-9680-C554FCA705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252CA-A1B6-5E40-8C26-0616057479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2652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rcRect l="19437" r="13227"/>
          <a:stretch/>
        </p:blipFill>
        <p:spPr bwMode="auto">
          <a:xfrm>
            <a:off x="432702" y="1780126"/>
            <a:ext cx="2886465" cy="2648999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/>
          <a:srcRect l="21457" r="11992"/>
          <a:stretch/>
        </p:blipFill>
        <p:spPr bwMode="auto">
          <a:xfrm>
            <a:off x="3730222" y="1748172"/>
            <a:ext cx="2887200" cy="2680953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 bwMode="auto">
          <a:xfrm>
            <a:off x="657871" y="17801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de-DE" sz="1200" dirty="0">
                <a:latin typeface="Arial"/>
                <a:cs typeface="Arial"/>
              </a:rPr>
              <a:t>a</a:t>
            </a:r>
            <a:endParaRPr dirty="0"/>
          </a:p>
        </p:txBody>
      </p:sp>
      <p:sp>
        <p:nvSpPr>
          <p:cNvPr id="12" name="Textfeld 11"/>
          <p:cNvSpPr txBox="1"/>
          <p:nvPr/>
        </p:nvSpPr>
        <p:spPr bwMode="auto">
          <a:xfrm>
            <a:off x="4095099" y="178012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de-DE" sz="1200" dirty="0">
                <a:latin typeface="Arial"/>
                <a:cs typeface="Arial"/>
              </a:rPr>
              <a:t>b</a:t>
            </a:r>
            <a:endParaRPr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E2E32D02-22FE-C648-B894-155F4EC9CA69}"/>
              </a:ext>
            </a:extLst>
          </p:cNvPr>
          <p:cNvSpPr txBox="1"/>
          <p:nvPr/>
        </p:nvSpPr>
        <p:spPr bwMode="auto">
          <a:xfrm>
            <a:off x="0" y="-84525"/>
            <a:ext cx="2074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49300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xmlns="" id="{7504AB0D-1F82-5F47-B584-BBADAF29740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1737011"/>
              </p:ext>
            </p:extLst>
          </p:nvPr>
        </p:nvGraphicFramePr>
        <p:xfrm>
          <a:off x="274319" y="2218672"/>
          <a:ext cx="11643359" cy="121492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765838">
                  <a:extLst>
                    <a:ext uri="{9D8B030D-6E8A-4147-A177-3AD203B41FA5}">
                      <a16:colId xmlns:a16="http://schemas.microsoft.com/office/drawing/2014/main" xmlns="" val="3443615829"/>
                    </a:ext>
                  </a:extLst>
                </a:gridCol>
                <a:gridCol w="934583">
                  <a:extLst>
                    <a:ext uri="{9D8B030D-6E8A-4147-A177-3AD203B41FA5}">
                      <a16:colId xmlns:a16="http://schemas.microsoft.com/office/drawing/2014/main" xmlns="" val="750876088"/>
                    </a:ext>
                  </a:extLst>
                </a:gridCol>
                <a:gridCol w="1168231">
                  <a:extLst>
                    <a:ext uri="{9D8B030D-6E8A-4147-A177-3AD203B41FA5}">
                      <a16:colId xmlns:a16="http://schemas.microsoft.com/office/drawing/2014/main" xmlns="" val="1340297204"/>
                    </a:ext>
                  </a:extLst>
                </a:gridCol>
                <a:gridCol w="1259093">
                  <a:extLst>
                    <a:ext uri="{9D8B030D-6E8A-4147-A177-3AD203B41FA5}">
                      <a16:colId xmlns:a16="http://schemas.microsoft.com/office/drawing/2014/main" xmlns="" val="1189254960"/>
                    </a:ext>
                  </a:extLst>
                </a:gridCol>
                <a:gridCol w="1129289">
                  <a:extLst>
                    <a:ext uri="{9D8B030D-6E8A-4147-A177-3AD203B41FA5}">
                      <a16:colId xmlns:a16="http://schemas.microsoft.com/office/drawing/2014/main" xmlns="" val="2395694037"/>
                    </a:ext>
                  </a:extLst>
                </a:gridCol>
                <a:gridCol w="1064388">
                  <a:extLst>
                    <a:ext uri="{9D8B030D-6E8A-4147-A177-3AD203B41FA5}">
                      <a16:colId xmlns:a16="http://schemas.microsoft.com/office/drawing/2014/main" xmlns="" val="2672968589"/>
                    </a:ext>
                  </a:extLst>
                </a:gridCol>
                <a:gridCol w="1051407">
                  <a:extLst>
                    <a:ext uri="{9D8B030D-6E8A-4147-A177-3AD203B41FA5}">
                      <a16:colId xmlns:a16="http://schemas.microsoft.com/office/drawing/2014/main" xmlns="" val="409511266"/>
                    </a:ext>
                  </a:extLst>
                </a:gridCol>
                <a:gridCol w="1285053">
                  <a:extLst>
                    <a:ext uri="{9D8B030D-6E8A-4147-A177-3AD203B41FA5}">
                      <a16:colId xmlns:a16="http://schemas.microsoft.com/office/drawing/2014/main" xmlns="" val="3551293144"/>
                    </a:ext>
                  </a:extLst>
                </a:gridCol>
                <a:gridCol w="869682">
                  <a:extLst>
                    <a:ext uri="{9D8B030D-6E8A-4147-A177-3AD203B41FA5}">
                      <a16:colId xmlns:a16="http://schemas.microsoft.com/office/drawing/2014/main" xmlns="" val="615864683"/>
                    </a:ext>
                  </a:extLst>
                </a:gridCol>
                <a:gridCol w="1025446">
                  <a:extLst>
                    <a:ext uri="{9D8B030D-6E8A-4147-A177-3AD203B41FA5}">
                      <a16:colId xmlns:a16="http://schemas.microsoft.com/office/drawing/2014/main" xmlns="" val="3931771861"/>
                    </a:ext>
                  </a:extLst>
                </a:gridCol>
                <a:gridCol w="1090349">
                  <a:extLst>
                    <a:ext uri="{9D8B030D-6E8A-4147-A177-3AD203B41FA5}">
                      <a16:colId xmlns:a16="http://schemas.microsoft.com/office/drawing/2014/main" xmlns="" val="1422305627"/>
                    </a:ext>
                  </a:extLst>
                </a:gridCol>
              </a:tblGrid>
              <a:tr h="132773">
                <a:tc gridSpan="8"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Table </a:t>
                      </a:r>
                      <a:r>
                        <a:rPr lang="de-DE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 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Statistics of quality-of-life surveys before and after repetitive PS</a:t>
                      </a:r>
                    </a:p>
                    <a:p>
                      <a:pPr algn="l" fontAlgn="b"/>
                      <a:endParaRPr lang="de-DE" sz="11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51090982"/>
                  </a:ext>
                </a:extLst>
              </a:tr>
              <a:tr h="123479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S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sical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ctioning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.l.d.t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sical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.l.d.t.emotional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lems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ergy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igu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otional well-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ing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cial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ctioning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hang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24592747"/>
                  </a:ext>
                </a:extLst>
              </a:tr>
              <a:tr h="17703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fore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5 ± 16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8 ± 24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6 ± 39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4 ± 45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9 ± 17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5 ± 24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8 ± 25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3 ± 16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3 ± 22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6 ± 25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40026769"/>
                  </a:ext>
                </a:extLst>
              </a:tr>
              <a:tr h="17703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0 ± 8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93.1 ± 11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.1 ± 20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8 ± 25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8 ± 20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0 ± 18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2 ± 15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3 ± 24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8 ± 16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7 ± 22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504477580"/>
                  </a:ext>
                </a:extLst>
              </a:tr>
              <a:tr h="17703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4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255141963"/>
                  </a:ext>
                </a:extLst>
              </a:tr>
            </a:tbl>
          </a:graphicData>
        </a:graphic>
      </p:graphicFrame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xmlns="" id="{0270C518-2D72-6245-99C8-8099ED7667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2627907"/>
              </p:ext>
            </p:extLst>
          </p:nvPr>
        </p:nvGraphicFramePr>
        <p:xfrm>
          <a:off x="274320" y="601539"/>
          <a:ext cx="11643359" cy="121492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765838">
                  <a:extLst>
                    <a:ext uri="{9D8B030D-6E8A-4147-A177-3AD203B41FA5}">
                      <a16:colId xmlns:a16="http://schemas.microsoft.com/office/drawing/2014/main" xmlns="" val="3443615829"/>
                    </a:ext>
                  </a:extLst>
                </a:gridCol>
                <a:gridCol w="934583">
                  <a:extLst>
                    <a:ext uri="{9D8B030D-6E8A-4147-A177-3AD203B41FA5}">
                      <a16:colId xmlns:a16="http://schemas.microsoft.com/office/drawing/2014/main" xmlns="" val="750876088"/>
                    </a:ext>
                  </a:extLst>
                </a:gridCol>
                <a:gridCol w="1168231">
                  <a:extLst>
                    <a:ext uri="{9D8B030D-6E8A-4147-A177-3AD203B41FA5}">
                      <a16:colId xmlns:a16="http://schemas.microsoft.com/office/drawing/2014/main" xmlns="" val="1340297204"/>
                    </a:ext>
                  </a:extLst>
                </a:gridCol>
                <a:gridCol w="1259093">
                  <a:extLst>
                    <a:ext uri="{9D8B030D-6E8A-4147-A177-3AD203B41FA5}">
                      <a16:colId xmlns:a16="http://schemas.microsoft.com/office/drawing/2014/main" xmlns="" val="1189254960"/>
                    </a:ext>
                  </a:extLst>
                </a:gridCol>
                <a:gridCol w="1129289">
                  <a:extLst>
                    <a:ext uri="{9D8B030D-6E8A-4147-A177-3AD203B41FA5}">
                      <a16:colId xmlns:a16="http://schemas.microsoft.com/office/drawing/2014/main" xmlns="" val="2395694037"/>
                    </a:ext>
                  </a:extLst>
                </a:gridCol>
                <a:gridCol w="1064388">
                  <a:extLst>
                    <a:ext uri="{9D8B030D-6E8A-4147-A177-3AD203B41FA5}">
                      <a16:colId xmlns:a16="http://schemas.microsoft.com/office/drawing/2014/main" xmlns="" val="2672968589"/>
                    </a:ext>
                  </a:extLst>
                </a:gridCol>
                <a:gridCol w="1051407">
                  <a:extLst>
                    <a:ext uri="{9D8B030D-6E8A-4147-A177-3AD203B41FA5}">
                      <a16:colId xmlns:a16="http://schemas.microsoft.com/office/drawing/2014/main" xmlns="" val="409511266"/>
                    </a:ext>
                  </a:extLst>
                </a:gridCol>
                <a:gridCol w="1285053">
                  <a:extLst>
                    <a:ext uri="{9D8B030D-6E8A-4147-A177-3AD203B41FA5}">
                      <a16:colId xmlns:a16="http://schemas.microsoft.com/office/drawing/2014/main" xmlns="" val="3551293144"/>
                    </a:ext>
                  </a:extLst>
                </a:gridCol>
                <a:gridCol w="869682">
                  <a:extLst>
                    <a:ext uri="{9D8B030D-6E8A-4147-A177-3AD203B41FA5}">
                      <a16:colId xmlns:a16="http://schemas.microsoft.com/office/drawing/2014/main" xmlns="" val="615864683"/>
                    </a:ext>
                  </a:extLst>
                </a:gridCol>
                <a:gridCol w="1025446">
                  <a:extLst>
                    <a:ext uri="{9D8B030D-6E8A-4147-A177-3AD203B41FA5}">
                      <a16:colId xmlns:a16="http://schemas.microsoft.com/office/drawing/2014/main" xmlns="" val="3931771861"/>
                    </a:ext>
                  </a:extLst>
                </a:gridCol>
                <a:gridCol w="1090349">
                  <a:extLst>
                    <a:ext uri="{9D8B030D-6E8A-4147-A177-3AD203B41FA5}">
                      <a16:colId xmlns:a16="http://schemas.microsoft.com/office/drawing/2014/main" xmlns="" val="1422305627"/>
                    </a:ext>
                  </a:extLst>
                </a:gridCol>
              </a:tblGrid>
              <a:tr h="132773">
                <a:tc gridSpan="8"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. </a:t>
                      </a:r>
                      <a:r>
                        <a:rPr lang="de-DE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1 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Statistics of quality-of-life surveys before and after first PS</a:t>
                      </a:r>
                    </a:p>
                    <a:p>
                      <a:pPr algn="l" fontAlgn="b"/>
                      <a:endParaRPr lang="de-DE" sz="11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51090982"/>
                  </a:ext>
                </a:extLst>
              </a:tr>
              <a:tr h="123479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S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sical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ctioning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.l.d.t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sical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.l.d.t.emotional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lems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ergy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igu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otional well-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ing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cial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ctioning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hang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24592747"/>
                  </a:ext>
                </a:extLst>
              </a:tr>
              <a:tr h="17703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fore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5 ± 16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8 ± 24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6 ± 39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4 ± 45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9 ± 17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5 ± 24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8 ± 25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3 ± 16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3 ± 22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6 ± 25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40026769"/>
                  </a:ext>
                </a:extLst>
              </a:tr>
              <a:tr h="17703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1 ± 16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77.8 ± 24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2 ± 35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9 ± 44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8 ± 22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5 ± 23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.9 ± 24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8 ± 21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5 ± 21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6 ± 28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504477580"/>
                  </a:ext>
                </a:extLst>
              </a:tr>
              <a:tr h="17703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1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5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5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0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4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8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3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39" marR="6639" marT="66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2551419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982411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xmlns="" id="{45AA8896-AC7C-E543-8CB5-A22833C111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3650784"/>
              </p:ext>
            </p:extLst>
          </p:nvPr>
        </p:nvGraphicFramePr>
        <p:xfrm>
          <a:off x="243840" y="0"/>
          <a:ext cx="9281160" cy="467044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848360">
                  <a:extLst>
                    <a:ext uri="{9D8B030D-6E8A-4147-A177-3AD203B41FA5}">
                      <a16:colId xmlns:a16="http://schemas.microsoft.com/office/drawing/2014/main" xmlns="" val="228733918"/>
                    </a:ext>
                  </a:extLst>
                </a:gridCol>
                <a:gridCol w="2832100">
                  <a:extLst>
                    <a:ext uri="{9D8B030D-6E8A-4147-A177-3AD203B41FA5}">
                      <a16:colId xmlns:a16="http://schemas.microsoft.com/office/drawing/2014/main" xmlns="" val="589477"/>
                    </a:ext>
                  </a:extLst>
                </a:gridCol>
                <a:gridCol w="1727200">
                  <a:extLst>
                    <a:ext uri="{9D8B030D-6E8A-4147-A177-3AD203B41FA5}">
                      <a16:colId xmlns:a16="http://schemas.microsoft.com/office/drawing/2014/main" xmlns="" val="423891341"/>
                    </a:ext>
                  </a:extLst>
                </a:gridCol>
                <a:gridCol w="2260600">
                  <a:extLst>
                    <a:ext uri="{9D8B030D-6E8A-4147-A177-3AD203B41FA5}">
                      <a16:colId xmlns:a16="http://schemas.microsoft.com/office/drawing/2014/main" xmlns="" val="2643397313"/>
                    </a:ext>
                  </a:extLst>
                </a:gridCol>
                <a:gridCol w="1612900">
                  <a:extLst>
                    <a:ext uri="{9D8B030D-6E8A-4147-A177-3AD203B41FA5}">
                      <a16:colId xmlns:a16="http://schemas.microsoft.com/office/drawing/2014/main" xmlns="" val="1673690755"/>
                    </a:ext>
                  </a:extLst>
                </a:gridCol>
              </a:tblGrid>
              <a:tr h="198947">
                <a:tc gridSpan="4"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Table </a:t>
                      </a:r>
                      <a:r>
                        <a:rPr lang="de-DE" sz="1100" b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 </a:t>
                      </a:r>
                      <a:r>
                        <a:rPr lang="de-DE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details for each individual patient</a:t>
                      </a:r>
                    </a:p>
                    <a:p>
                      <a:pPr algn="l" fontAlgn="b"/>
                      <a:endParaRPr lang="de-DE" sz="11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269931699"/>
                  </a:ext>
                </a:extLst>
              </a:tr>
              <a:tr h="346914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de-DE" sz="11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rovement</a:t>
                      </a:r>
                      <a:r>
                        <a:rPr lang="de-DE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F-36 </a:t>
                      </a:r>
                      <a:r>
                        <a:rPr lang="de-DE" sz="11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n</a:t>
                      </a:r>
                      <a:r>
                        <a:rPr lang="de-DE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≥ 20 </a:t>
                      </a:r>
                      <a:r>
                        <a:rPr lang="de-DE" sz="11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ints</a:t>
                      </a:r>
                      <a:endParaRPr lang="de-DE" sz="1100" b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rovement</a:t>
                      </a:r>
                      <a:r>
                        <a:rPr lang="de-DE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ESS ≥ 5 %</a:t>
                      </a:r>
                      <a:endParaRPr lang="de-DE" sz="11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-36 </a:t>
                      </a:r>
                      <a:r>
                        <a:rPr lang="de-DE" sz="11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n</a:t>
                      </a:r>
                      <a:r>
                        <a:rPr lang="de-DE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≥ 85 </a:t>
                      </a:r>
                      <a:r>
                        <a:rPr lang="de-DE" sz="11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ints</a:t>
                      </a:r>
                      <a:endParaRPr lang="de-DE" sz="11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S ≥ 85 %</a:t>
                      </a:r>
                      <a:endParaRPr lang="de-DE" sz="11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715917150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627232070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627153610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894780670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508271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422838912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322243528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322217035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43439005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701627135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130600914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143078758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94688013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081039179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697881339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599247088"/>
                  </a:ext>
                </a:extLst>
              </a:tr>
              <a:tr h="24868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26" marR="9326" marT="93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1061061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526915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xmlns="" id="{3644F960-7B7A-2646-AB62-8D3A77D55A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5209733"/>
              </p:ext>
            </p:extLst>
          </p:nvPr>
        </p:nvGraphicFramePr>
        <p:xfrm>
          <a:off x="711576" y="3152139"/>
          <a:ext cx="6623944" cy="288925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2148606">
                  <a:extLst>
                    <a:ext uri="{9D8B030D-6E8A-4147-A177-3AD203B41FA5}">
                      <a16:colId xmlns:a16="http://schemas.microsoft.com/office/drawing/2014/main" xmlns="" val="3215638503"/>
                    </a:ext>
                  </a:extLst>
                </a:gridCol>
                <a:gridCol w="2170873">
                  <a:extLst>
                    <a:ext uri="{9D8B030D-6E8A-4147-A177-3AD203B41FA5}">
                      <a16:colId xmlns:a16="http://schemas.microsoft.com/office/drawing/2014/main" xmlns="" val="2725892833"/>
                    </a:ext>
                  </a:extLst>
                </a:gridCol>
                <a:gridCol w="2304465">
                  <a:extLst>
                    <a:ext uri="{9D8B030D-6E8A-4147-A177-3AD203B41FA5}">
                      <a16:colId xmlns:a16="http://schemas.microsoft.com/office/drawing/2014/main" xmlns="" val="2397496817"/>
                    </a:ext>
                  </a:extLst>
                </a:gridCol>
              </a:tblGrid>
              <a:tr h="1905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</a:t>
                      </a:r>
                      <a:r>
                        <a:rPr lang="de-DE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3 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Outcome prediction with binary logistic regression after repetitive PS (p-values)</a:t>
                      </a:r>
                    </a:p>
                    <a:p>
                      <a:pPr algn="l" fontAlgn="b"/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734920139"/>
                  </a:ext>
                </a:extLst>
              </a:tr>
              <a:tr h="121384">
                <a:tc>
                  <a:txBody>
                    <a:bodyPr/>
                    <a:lstStyle/>
                    <a:p>
                      <a:pPr algn="l" fontAlgn="ctr"/>
                      <a:endParaRPr lang="de-DE" sz="11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endParaRPr lang="de-DE" sz="11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-36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n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≥ 85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ints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S ≥ 85 %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3734049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52523632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14327054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alization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2236297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ious therapy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27604211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of used accesse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50908808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erial used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997940501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antity, mL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3593645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formed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ies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188563588"/>
                  </a:ext>
                </a:extLst>
              </a:tr>
            </a:tbl>
          </a:graphicData>
        </a:graphic>
      </p:graphicFrame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xmlns="" id="{BE50FB7E-1B6D-AB4F-9655-C3738A0053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964825"/>
              </p:ext>
            </p:extLst>
          </p:nvPr>
        </p:nvGraphicFramePr>
        <p:xfrm>
          <a:off x="711576" y="202477"/>
          <a:ext cx="6623944" cy="288925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2148606">
                  <a:extLst>
                    <a:ext uri="{9D8B030D-6E8A-4147-A177-3AD203B41FA5}">
                      <a16:colId xmlns:a16="http://schemas.microsoft.com/office/drawing/2014/main" xmlns="" val="3215638503"/>
                    </a:ext>
                  </a:extLst>
                </a:gridCol>
                <a:gridCol w="2733256">
                  <a:extLst>
                    <a:ext uri="{9D8B030D-6E8A-4147-A177-3AD203B41FA5}">
                      <a16:colId xmlns:a16="http://schemas.microsoft.com/office/drawing/2014/main" xmlns="" val="2725892833"/>
                    </a:ext>
                  </a:extLst>
                </a:gridCol>
                <a:gridCol w="1742082">
                  <a:extLst>
                    <a:ext uri="{9D8B030D-6E8A-4147-A177-3AD203B41FA5}">
                      <a16:colId xmlns:a16="http://schemas.microsoft.com/office/drawing/2014/main" xmlns="" val="2397496817"/>
                    </a:ext>
                  </a:extLst>
                </a:gridCol>
              </a:tblGrid>
              <a:tr h="114273"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</a:t>
                      </a:r>
                      <a:r>
                        <a:rPr lang="de-DE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3 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Outcome prediction with binary logistic regression after the first PS (p-values)</a:t>
                      </a:r>
                    </a:p>
                    <a:p>
                      <a:pPr algn="l" fontAlgn="b"/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734920139"/>
                  </a:ext>
                </a:extLst>
              </a:tr>
              <a:tr h="121384">
                <a:tc>
                  <a:txBody>
                    <a:bodyPr/>
                    <a:lstStyle/>
                    <a:p>
                      <a:pPr algn="l" fontAlgn="ctr"/>
                      <a:endParaRPr lang="de-DE" sz="11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endParaRPr lang="de-DE" sz="11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rovement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F-36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n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≥ 20 </a:t>
                      </a:r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ints</a:t>
                      </a:r>
                      <a:endParaRPr lang="de-DE" sz="11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rovement</a:t>
                      </a:r>
                      <a:r>
                        <a:rPr lang="de-DE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ESS ≥ 5 %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3734049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52523632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14327054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alization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2236297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ious therapy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27604211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of used accesse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50908808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erial used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997940501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antity, mL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3593645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formed</a:t>
                      </a:r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ies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1885635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89473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2</Words>
  <Application>Microsoft Office PowerPoint</Application>
  <PresentationFormat>Widescreen</PresentationFormat>
  <Paragraphs>241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rjam Gerwing</dc:creator>
  <cp:lastModifiedBy>MDPI</cp:lastModifiedBy>
  <cp:revision>94</cp:revision>
  <dcterms:created xsi:type="dcterms:W3CDTF">2022-03-16T20:09:56Z</dcterms:created>
  <dcterms:modified xsi:type="dcterms:W3CDTF">2022-06-09T13:10:27Z</dcterms:modified>
</cp:coreProperties>
</file>